
<file path=[Content_Types].xml><?xml version="1.0" encoding="utf-8"?>
<Types xmlns="http://schemas.openxmlformats.org/package/2006/content-types">
  <Default Extension="bin" ContentType="application/vnd.openxmlformats-officedocument.presentationml.printerSettings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jpg" ContentType="image/jpe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7" d="100"/>
          <a:sy n="127" d="100"/>
        </p:scale>
        <p:origin x="-192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printerSettings" Target="printerSettings/printerSettings1.bin"/><Relationship Id="rId9" Type="http://schemas.openxmlformats.org/officeDocument/2006/relationships/customXml" Target="../customXml/item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C8675-E531-AD4A-A77D-FD48C3A0CF17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2DE4F-7CC4-1845-BF33-4706BAF14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4632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C8675-E531-AD4A-A77D-FD48C3A0CF17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2DE4F-7CC4-1845-BF33-4706BAF14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8372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C8675-E531-AD4A-A77D-FD48C3A0CF17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2DE4F-7CC4-1845-BF33-4706BAF14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190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C8675-E531-AD4A-A77D-FD48C3A0CF17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2DE4F-7CC4-1845-BF33-4706BAF14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227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C8675-E531-AD4A-A77D-FD48C3A0CF17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2DE4F-7CC4-1845-BF33-4706BAF14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703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C8675-E531-AD4A-A77D-FD48C3A0CF17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2DE4F-7CC4-1845-BF33-4706BAF14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2421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C8675-E531-AD4A-A77D-FD48C3A0CF17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2DE4F-7CC4-1845-BF33-4706BAF14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3069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C8675-E531-AD4A-A77D-FD48C3A0CF17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2DE4F-7CC4-1845-BF33-4706BAF14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0412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C8675-E531-AD4A-A77D-FD48C3A0CF17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2DE4F-7CC4-1845-BF33-4706BAF14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8931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C8675-E531-AD4A-A77D-FD48C3A0CF17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2DE4F-7CC4-1845-BF33-4706BAF14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000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EC8675-E531-AD4A-A77D-FD48C3A0CF17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2DE4F-7CC4-1845-BF33-4706BAF14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672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EC8675-E531-AD4A-A77D-FD48C3A0CF17}" type="datetimeFigureOut">
              <a:rPr lang="en-US" smtClean="0"/>
              <a:t>2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82DE4F-7CC4-1845-BF33-4706BAF14B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991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upp 1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1867434"/>
            <a:ext cx="2880000" cy="3123133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155996" y="157130"/>
            <a:ext cx="4572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ctr"/>
            <a:r>
              <a:rPr lang="en-US" dirty="0" smtClean="0"/>
              <a:t>SDS-PAGE analyzing the expression of the NIT1</a:t>
            </a:r>
            <a:r>
              <a:rPr lang="en-US" dirty="0"/>
              <a:t>:c-myc fusion construct </a:t>
            </a:r>
            <a:r>
              <a:rPr lang="en-US" dirty="0" smtClean="0"/>
              <a:t>in </a:t>
            </a:r>
            <a:r>
              <a:rPr lang="en-US" i="1" dirty="0"/>
              <a:t>Escherichia coli</a:t>
            </a:r>
            <a:r>
              <a:rPr lang="en-US" dirty="0" smtClean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499283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upp 2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1099611"/>
            <a:ext cx="2880000" cy="5298843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084901" y="157130"/>
            <a:ext cx="497419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 smtClean="0"/>
              <a:t>Enzymatic assay providing evidence for the activity of the recombinant NIT1</a:t>
            </a:r>
            <a:r>
              <a:rPr lang="en-US" dirty="0"/>
              <a:t>:c-myc fusion </a:t>
            </a:r>
            <a:r>
              <a:rPr lang="en-US" dirty="0" smtClean="0"/>
              <a:t>construct</a:t>
            </a:r>
            <a:r>
              <a:rPr lang="en-US" dirty="0" smtClean="0">
                <a:effectLst/>
              </a:rPr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598225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50FB4CD0F454C4A92D9C0FA6E32AAE3" ma:contentTypeVersion="7" ma:contentTypeDescription="Create a new document." ma:contentTypeScope="" ma:versionID="a5800d4522ad6bb42b1b471843bdcecc">
  <xsd:schema xmlns:xsd="http://www.w3.org/2001/XMLSchema" xmlns:p="http://schemas.microsoft.com/office/2006/metadata/properties" xmlns:ns2="ad5e6ac6-7e28-44ff-b599-4b096ee3745e" targetNamespace="http://schemas.microsoft.com/office/2006/metadata/properties" ma:root="true" ma:fieldsID="9c3be0cea3e8431379a50517fac3f2af" ns2:_="">
    <xsd:import namespace="ad5e6ac6-7e28-44ff-b599-4b096ee3745e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ad5e6ac6-7e28-44ff-b599-4b096ee3745e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Checked_x0020_Out_x0020_To xmlns="ad5e6ac6-7e28-44ff-b599-4b096ee3745e">
      <UserInfo>
        <DisplayName/>
        <AccountId xsi:nil="true"/>
        <AccountType/>
      </UserInfo>
    </Checked_x0020_Out_x0020_To>
    <IsDeleted xmlns="ad5e6ac6-7e28-44ff-b599-4b096ee3745e">false</IsDeleted>
    <FileFormat xmlns="ad5e6ac6-7e28-44ff-b599-4b096ee3745e">PPTX</FileFormat>
    <TitleName xmlns="ad5e6ac6-7e28-44ff-b599-4b096ee3745e">Presentation 2.PPTX</TitleName>
    <StageName xmlns="ad5e6ac6-7e28-44ff-b599-4b096ee3745e" xsi:nil="true"/>
    <DocumentType xmlns="ad5e6ac6-7e28-44ff-b599-4b096ee3745e">Presentation</DocumentType>
    <DocumentId xmlns="ad5e6ac6-7e28-44ff-b599-4b096ee3745e">Presentation 2.PPTX</DocumentId>
  </documentManagement>
</p:properties>
</file>

<file path=customXml/itemProps1.xml><?xml version="1.0" encoding="utf-8"?>
<ds:datastoreItem xmlns:ds="http://schemas.openxmlformats.org/officeDocument/2006/customXml" ds:itemID="{157ECDE4-A830-43F5-ACF3-4DCC9F522D0E}"/>
</file>

<file path=customXml/itemProps2.xml><?xml version="1.0" encoding="utf-8"?>
<ds:datastoreItem xmlns:ds="http://schemas.openxmlformats.org/officeDocument/2006/customXml" ds:itemID="{A35BDB06-F9AB-47C3-9B94-B0C9D703CB54}"/>
</file>

<file path=customXml/itemProps3.xml><?xml version="1.0" encoding="utf-8"?>
<ds:datastoreItem xmlns:ds="http://schemas.openxmlformats.org/officeDocument/2006/customXml" ds:itemID="{C90860EB-7095-4C65-8A19-FC4830E70DA4}"/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35</Words>
  <Application>Microsoft Macintosh PowerPoint</Application>
  <PresentationFormat>On-screen Show (4:3)</PresentationFormat>
  <Paragraphs>2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Centro de Biotecnología y Genómica de Planta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an Pollmann</dc:creator>
  <cp:lastModifiedBy>Stephan Pollmann</cp:lastModifiedBy>
  <cp:revision>2</cp:revision>
  <dcterms:created xsi:type="dcterms:W3CDTF">2016-11-29T17:18:17Z</dcterms:created>
  <dcterms:modified xsi:type="dcterms:W3CDTF">2016-11-29T17:38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50FB4CD0F454C4A92D9C0FA6E32AAE3</vt:lpwstr>
  </property>
</Properties>
</file>